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9.png" ContentType="image/png"/>
  <Override PartName="/ppt/media/image17.wmf" ContentType="image/x-wmf"/>
  <Override PartName="/ppt/media/image12.wmf" ContentType="image/x-wmf"/>
  <Override PartName="/ppt/media/image8.png" ContentType="image/png"/>
  <Override PartName="/ppt/media/image16.png" ContentType="image/png"/>
  <Override PartName="/ppt/media/image1.png" ContentType="image/png"/>
  <Override PartName="/ppt/media/image2.wmf" ContentType="image/x-wmf"/>
  <Override PartName="/ppt/media/image18.wmf" ContentType="image/x-wmf"/>
  <Override PartName="/ppt/media/image5.jpeg" ContentType="image/jpeg"/>
  <Override PartName="/ppt/media/image14.wmf" ContentType="image/x-wmf"/>
  <Override PartName="/ppt/media/image6.png" ContentType="image/png"/>
  <Override PartName="/ppt/media/image10.wmf" ContentType="image/x-wmf"/>
  <Override PartName="/ppt/media/image4.jpeg" ContentType="image/jpeg"/>
  <Override PartName="/ppt/media/image15.wmf" ContentType="image/x-wmf"/>
  <Override PartName="/ppt/media/image7.png" ContentType="image/png"/>
  <Override PartName="/ppt/media/image3.png" ContentType="image/png"/>
  <Override PartName="/ppt/media/image11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3FB7B-FAD9-4D15-81B9-73D5E97602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93D1C-5459-435C-99BE-FDC16352BD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FFB903-C28E-417D-87D9-A2B4179EBF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90A4B-2FFA-46C0-9536-2386ADD7E9A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52775-A9CD-4F82-9B84-6F90AB9C66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FA26D-25A8-489C-B97F-0B53CF1AF2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B93B2B-7B95-453E-BE8B-165018B791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43521-81D1-47D6-AF13-7C62D24B50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CD49A-4DD8-4F6A-8FDB-98B3DAE760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E9E01-7C80-43B1-AA29-45C8D381AE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BF387-9E21-4041-B78B-6B0C2B7BAD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6509B-1DBE-4DA0-9C35-C3954E0CAF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9DF05AB-1C5E-45AB-B674-89428722CEE0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oleObject" Target="../embeddings/oleObject1.bin"/><Relationship Id="rId6" Type="http://schemas.openxmlformats.org/officeDocument/2006/relationships/image" Target="../media/image10.wmf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5.wmf"/><Relationship Id="rId11" Type="http://schemas.openxmlformats.org/officeDocument/2006/relationships/image" Target="../media/image16.png"/><Relationship Id="rId1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2"/>
          <p:cNvSpPr/>
          <p:nvPr/>
        </p:nvSpPr>
        <p:spPr>
          <a:xfrm>
            <a:off x="4257000" y="8766000"/>
            <a:ext cx="273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Supp. data. Figure S1 Coursan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Graphique 6" descr=""/>
          <p:cNvPicPr/>
          <p:nvPr/>
        </p:nvPicPr>
        <p:blipFill>
          <a:blip r:embed="rId1"/>
          <a:stretch/>
        </p:blipFill>
        <p:spPr>
          <a:xfrm>
            <a:off x="122400" y="2030400"/>
            <a:ext cx="6735600" cy="3309840"/>
          </a:xfrm>
          <a:prstGeom prst="rect">
            <a:avLst/>
          </a:prstGeom>
          <a:ln w="0">
            <a:noFill/>
          </a:ln>
        </p:spPr>
      </p:pic>
      <p:pic>
        <p:nvPicPr>
          <p:cNvPr id="43" name="Image 8" descr=""/>
          <p:cNvPicPr/>
          <p:nvPr/>
        </p:nvPicPr>
        <p:blipFill>
          <a:blip r:embed="rId2"/>
          <a:srcRect l="45203" t="0" r="0" b="74480"/>
          <a:stretch/>
        </p:blipFill>
        <p:spPr>
          <a:xfrm>
            <a:off x="736560" y="2230560"/>
            <a:ext cx="2222640" cy="67608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10"/>
          <p:cNvSpPr/>
          <p:nvPr/>
        </p:nvSpPr>
        <p:spPr>
          <a:xfrm>
            <a:off x="414360" y="5776920"/>
            <a:ext cx="63612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. Figure S1: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dividual daily intake of total added fructose based on daily consumption of sweet products and beverage from each volunteers. 18 volunteers out of 49 (36,7% of the individuals) consumed more than 25g of added fructose per day, which is above the limit recommended by the WHO in 201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Connecteur droit 2"/>
          <p:cNvSpPr/>
          <p:nvPr/>
        </p:nvSpPr>
        <p:spPr>
          <a:xfrm>
            <a:off x="414360" y="3859200"/>
            <a:ext cx="636120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2"/>
          <p:cNvSpPr/>
          <p:nvPr/>
        </p:nvSpPr>
        <p:spPr>
          <a:xfrm>
            <a:off x="4257000" y="8766000"/>
            <a:ext cx="273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Supp. data. Figure S2 Coursan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4"/>
          <p:cNvSpPr/>
          <p:nvPr/>
        </p:nvSpPr>
        <p:spPr>
          <a:xfrm>
            <a:off x="114840" y="4208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5"/>
          <p:cNvSpPr/>
          <p:nvPr/>
        </p:nvSpPr>
        <p:spPr>
          <a:xfrm>
            <a:off x="3559320" y="420840"/>
            <a:ext cx="28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7"/>
          <p:cNvSpPr/>
          <p:nvPr/>
        </p:nvSpPr>
        <p:spPr>
          <a:xfrm>
            <a:off x="258840" y="6932520"/>
            <a:ext cx="60260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Supp. Figure S2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: Phylum composition of cecal microbiota from 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(A)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normo- or malabsorptive volunteers or 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(B)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WT (WT5F) or GLUT5_KO mice (GLUT5_KO5F) fed a fructose 5% diet for 4 weeks or GLUT5_KO mice (GLUT5_KO0F) fed a control diet without any fructose for 4 weeks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Phylum abundance data were compared using Kruskal-Wallis test followed by Dunn’s multiple comparison test: * indicates significant difference between WT5F and GLUT5_KO5F;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Calibri"/>
              </a:rPr>
              <a:t>$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 indicates significant difference between GLUT5_KO0F and GLUT5_KO5F ,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Calibri"/>
              </a:rPr>
              <a:t>#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 indicates significant difference between GLUT5_KO0F and WT5F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Image 6" descr=""/>
          <p:cNvPicPr/>
          <p:nvPr/>
        </p:nvPicPr>
        <p:blipFill>
          <a:blip r:embed="rId1"/>
          <a:srcRect l="60645" t="41155" r="1782" b="28422"/>
          <a:stretch/>
        </p:blipFill>
        <p:spPr>
          <a:xfrm>
            <a:off x="879480" y="4938840"/>
            <a:ext cx="1695600" cy="1333440"/>
          </a:xfrm>
          <a:prstGeom prst="rect">
            <a:avLst/>
          </a:prstGeom>
          <a:ln w="0">
            <a:noFill/>
          </a:ln>
        </p:spPr>
      </p:pic>
      <p:pic>
        <p:nvPicPr>
          <p:cNvPr id="51" name="Image 13" descr=""/>
          <p:cNvPicPr/>
          <p:nvPr/>
        </p:nvPicPr>
        <p:blipFill>
          <a:blip r:embed="rId2"/>
          <a:stretch/>
        </p:blipFill>
        <p:spPr>
          <a:xfrm>
            <a:off x="406440" y="496800"/>
            <a:ext cx="2095560" cy="3810240"/>
          </a:xfrm>
          <a:prstGeom prst="rect">
            <a:avLst/>
          </a:prstGeom>
          <a:ln w="0">
            <a:noFill/>
          </a:ln>
        </p:spPr>
      </p:pic>
      <p:pic>
        <p:nvPicPr>
          <p:cNvPr id="52" name="Image 17" descr=""/>
          <p:cNvPicPr/>
          <p:nvPr/>
        </p:nvPicPr>
        <p:blipFill>
          <a:blip r:embed="rId3"/>
          <a:stretch/>
        </p:blipFill>
        <p:spPr>
          <a:xfrm>
            <a:off x="3797280" y="441360"/>
            <a:ext cx="2354400" cy="4351320"/>
          </a:xfrm>
          <a:prstGeom prst="rect">
            <a:avLst/>
          </a:prstGeom>
          <a:ln w="0">
            <a:noFill/>
          </a:ln>
        </p:spPr>
      </p:pic>
      <p:grpSp>
        <p:nvGrpSpPr>
          <p:cNvPr id="53" name="Groupe 2"/>
          <p:cNvGrpSpPr/>
          <p:nvPr/>
        </p:nvGrpSpPr>
        <p:grpSpPr>
          <a:xfrm>
            <a:off x="4357800" y="4888080"/>
            <a:ext cx="1793880" cy="1334160"/>
            <a:chOff x="4357800" y="4888080"/>
            <a:chExt cx="1793880" cy="1334160"/>
          </a:xfrm>
        </p:grpSpPr>
        <p:pic>
          <p:nvPicPr>
            <p:cNvPr id="54" name="Image 16" descr=""/>
            <p:cNvPicPr/>
            <p:nvPr/>
          </p:nvPicPr>
          <p:blipFill>
            <a:blip r:embed="rId4"/>
            <a:srcRect l="61686" t="42228" r="1874" b="28292"/>
            <a:stretch/>
          </p:blipFill>
          <p:spPr>
            <a:xfrm>
              <a:off x="4357800" y="4888080"/>
              <a:ext cx="1621080" cy="1334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ZoneTexte 1"/>
            <p:cNvSpPr/>
            <p:nvPr/>
          </p:nvSpPr>
          <p:spPr>
            <a:xfrm>
              <a:off x="5338440" y="5922720"/>
              <a:ext cx="317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ZoneTexte 10"/>
            <p:cNvSpPr/>
            <p:nvPr/>
          </p:nvSpPr>
          <p:spPr>
            <a:xfrm>
              <a:off x="5180760" y="5701680"/>
              <a:ext cx="315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 baseline="30000">
                  <a:solidFill>
                    <a:srgbClr val="000000"/>
                  </a:solidFill>
                  <a:latin typeface="Calibri"/>
                </a:rPr>
                <a:t>$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ZoneTexte 11"/>
            <p:cNvSpPr/>
            <p:nvPr/>
          </p:nvSpPr>
          <p:spPr>
            <a:xfrm>
              <a:off x="5009400" y="5842440"/>
              <a:ext cx="64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 baseline="30000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ZoneTexte 12"/>
            <p:cNvSpPr/>
            <p:nvPr/>
          </p:nvSpPr>
          <p:spPr>
            <a:xfrm>
              <a:off x="5507640" y="5563080"/>
              <a:ext cx="64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 baseline="30000">
                  <a:solidFill>
                    <a:srgbClr val="000000"/>
                  </a:solidFill>
                  <a:latin typeface="Calibri"/>
                </a:rPr>
                <a:t>#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" name="Rectangle 1"/>
          <p:cNvSpPr/>
          <p:nvPr/>
        </p:nvSpPr>
        <p:spPr>
          <a:xfrm>
            <a:off x="1101960" y="13968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Phyl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15"/>
          <p:cNvSpPr/>
          <p:nvPr/>
        </p:nvSpPr>
        <p:spPr>
          <a:xfrm>
            <a:off x="4646880" y="109440"/>
            <a:ext cx="87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Phylu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16"/>
          <p:cNvSpPr/>
          <p:nvPr/>
        </p:nvSpPr>
        <p:spPr>
          <a:xfrm rot="16200000">
            <a:off x="2955960" y="2477160"/>
            <a:ext cx="1599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elative abund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17"/>
          <p:cNvSpPr/>
          <p:nvPr/>
        </p:nvSpPr>
        <p:spPr>
          <a:xfrm rot="16200000">
            <a:off x="-490320" y="2259720"/>
            <a:ext cx="1599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elative abund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Image 7" descr=""/>
          <p:cNvPicPr/>
          <p:nvPr/>
        </p:nvPicPr>
        <p:blipFill>
          <a:blip r:embed="rId1"/>
          <a:srcRect l="52560" t="1125" r="2276" b="1078"/>
          <a:stretch/>
        </p:blipFill>
        <p:spPr>
          <a:xfrm>
            <a:off x="3903840" y="336600"/>
            <a:ext cx="1591920" cy="3052800"/>
          </a:xfrm>
          <a:prstGeom prst="rect">
            <a:avLst/>
          </a:prstGeom>
          <a:ln w="0">
            <a:noFill/>
          </a:ln>
        </p:spPr>
      </p:pic>
      <p:pic>
        <p:nvPicPr>
          <p:cNvPr id="64" name="Image 8" descr=""/>
          <p:cNvPicPr/>
          <p:nvPr/>
        </p:nvPicPr>
        <p:blipFill>
          <a:blip r:embed="rId2"/>
          <a:srcRect l="842" t="1125" r="54790" b="1078"/>
          <a:stretch/>
        </p:blipFill>
        <p:spPr>
          <a:xfrm>
            <a:off x="453960" y="299880"/>
            <a:ext cx="1563840" cy="3052800"/>
          </a:xfrm>
          <a:prstGeom prst="rect">
            <a:avLst/>
          </a:prstGeom>
          <a:ln w="0">
            <a:noFill/>
          </a:ln>
        </p:spPr>
      </p:pic>
      <p:pic>
        <p:nvPicPr>
          <p:cNvPr id="65" name="Image 9" descr=""/>
          <p:cNvPicPr/>
          <p:nvPr/>
        </p:nvPicPr>
        <p:blipFill>
          <a:blip r:embed="rId3"/>
          <a:srcRect l="61555" t="41165" r="2785" b="28574"/>
          <a:stretch/>
        </p:blipFill>
        <p:spPr>
          <a:xfrm>
            <a:off x="2139840" y="1011240"/>
            <a:ext cx="1424160" cy="1174680"/>
          </a:xfrm>
          <a:prstGeom prst="rect">
            <a:avLst/>
          </a:prstGeom>
          <a:ln w="0">
            <a:noFill/>
          </a:ln>
        </p:spPr>
      </p:pic>
      <p:pic>
        <p:nvPicPr>
          <p:cNvPr id="66" name="Image 10" descr=""/>
          <p:cNvPicPr/>
          <p:nvPr/>
        </p:nvPicPr>
        <p:blipFill>
          <a:blip r:embed="rId4"/>
          <a:srcRect l="65092" t="10109" r="1152" b="38711"/>
          <a:stretch/>
        </p:blipFill>
        <p:spPr>
          <a:xfrm>
            <a:off x="5495760" y="528480"/>
            <a:ext cx="1362240" cy="2224080"/>
          </a:xfrm>
          <a:prstGeom prst="rect">
            <a:avLst/>
          </a:prstGeom>
          <a:ln w="0">
            <a:noFill/>
          </a:ln>
        </p:spPr>
      </p:pic>
      <p:sp>
        <p:nvSpPr>
          <p:cNvPr id="67" name="ZoneTexte 9"/>
          <p:cNvSpPr/>
          <p:nvPr/>
        </p:nvSpPr>
        <p:spPr>
          <a:xfrm>
            <a:off x="4257000" y="8766000"/>
            <a:ext cx="273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Supp. data. Figure S3 Coursan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ZoneTexte 4"/>
          <p:cNvSpPr/>
          <p:nvPr/>
        </p:nvSpPr>
        <p:spPr>
          <a:xfrm>
            <a:off x="114840" y="1285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ZoneTexte 5"/>
          <p:cNvSpPr/>
          <p:nvPr/>
        </p:nvSpPr>
        <p:spPr>
          <a:xfrm>
            <a:off x="187200" y="403560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14"/>
          <p:cNvSpPr/>
          <p:nvPr/>
        </p:nvSpPr>
        <p:spPr>
          <a:xfrm>
            <a:off x="813600" y="57240"/>
            <a:ext cx="79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Phylum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15"/>
          <p:cNvSpPr/>
          <p:nvPr/>
        </p:nvSpPr>
        <p:spPr>
          <a:xfrm>
            <a:off x="4402080" y="60480"/>
            <a:ext cx="854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Famili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7"/>
          <p:cNvSpPr/>
          <p:nvPr/>
        </p:nvSpPr>
        <p:spPr>
          <a:xfrm>
            <a:off x="112680" y="7643880"/>
            <a:ext cx="66708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Supp. Figure S3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: WT and GLUT5_KO mice were fed 0% fructose or 5% fructose diet for 10 days. Data show a lack of changes in the phylum and family composition of fecal microbiota in WT mice fed a 0% fructose (WT0F) or 5% fructose (WT5F) diet for 10 days 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(A).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Similar body weight  was observed between WT and GLUT5KO mice fed either 0% fructose (WT0F or GLUT5KO_0F) or 5% fructose (WT5F or GLUT5KO_5F) diet for 10 days (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). WT and GLUT5KO mice also exhibited similar daily food intake after 10 days on a 5% fructose diet 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(C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3" name="Objet 19"/>
          <p:cNvGraphicFramePr/>
          <p:nvPr/>
        </p:nvGraphicFramePr>
        <p:xfrm>
          <a:off x="258840" y="3862440"/>
          <a:ext cx="5289480" cy="38275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74" name="Objet 1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58840" y="3862440"/>
                    <a:ext cx="5289480" cy="3827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5" name="ZoneTexte 5"/>
          <p:cNvSpPr/>
          <p:nvPr/>
        </p:nvSpPr>
        <p:spPr>
          <a:xfrm>
            <a:off x="3762360" y="403560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13"/>
          <p:cNvSpPr/>
          <p:nvPr/>
        </p:nvSpPr>
        <p:spPr>
          <a:xfrm rot="16200000">
            <a:off x="3011400" y="1762200"/>
            <a:ext cx="1599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elative abund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14"/>
          <p:cNvSpPr/>
          <p:nvPr/>
        </p:nvSpPr>
        <p:spPr>
          <a:xfrm rot="16200000">
            <a:off x="-482400" y="1745280"/>
            <a:ext cx="1599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elative abundanc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8" name="Objet 2"/>
          <p:cNvGraphicFramePr/>
          <p:nvPr/>
        </p:nvGraphicFramePr>
        <p:xfrm>
          <a:off x="1603440" y="2487600"/>
          <a:ext cx="1479600" cy="2076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9" name="Obje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03440" y="2487600"/>
                    <a:ext cx="1479600" cy="2076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0" name="Objet 3"/>
          <p:cNvGraphicFramePr/>
          <p:nvPr/>
        </p:nvGraphicFramePr>
        <p:xfrm>
          <a:off x="3220920" y="2487600"/>
          <a:ext cx="1479600" cy="2076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81" name="Obje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20920" y="2487600"/>
                    <a:ext cx="1479600" cy="2076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2" name="Objet 4"/>
          <p:cNvGraphicFramePr/>
          <p:nvPr/>
        </p:nvGraphicFramePr>
        <p:xfrm>
          <a:off x="4827600" y="2490840"/>
          <a:ext cx="1488960" cy="20667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3" name="Obje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827600" y="2490840"/>
                    <a:ext cx="1488960" cy="2066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4" name="ZoneTexte 6"/>
          <p:cNvSpPr/>
          <p:nvPr/>
        </p:nvSpPr>
        <p:spPr>
          <a:xfrm rot="16200000">
            <a:off x="5680800" y="2930760"/>
            <a:ext cx="17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omeostatic gen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7"/>
          <p:cNvSpPr/>
          <p:nvPr/>
        </p:nvSpPr>
        <p:spPr>
          <a:xfrm>
            <a:off x="6377040" y="2200320"/>
            <a:ext cx="384120" cy="1738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6" name="Objet 8"/>
          <p:cNvGraphicFramePr/>
          <p:nvPr/>
        </p:nvGraphicFramePr>
        <p:xfrm>
          <a:off x="196920" y="2487600"/>
          <a:ext cx="1479600" cy="20764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87" name="Objet 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96920" y="2487600"/>
                    <a:ext cx="1479600" cy="2076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" name="ZoneTexte 9"/>
          <p:cNvSpPr/>
          <p:nvPr/>
        </p:nvSpPr>
        <p:spPr>
          <a:xfrm>
            <a:off x="4257000" y="8766000"/>
            <a:ext cx="2730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Supp. data. Figure S4 Coursan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5"/>
          <p:cNvSpPr/>
          <p:nvPr/>
        </p:nvSpPr>
        <p:spPr>
          <a:xfrm>
            <a:off x="93600" y="4579920"/>
            <a:ext cx="66675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 u="sng">
                <a:solidFill>
                  <a:srgbClr val="000000"/>
                </a:solidFill>
                <a:uFillTx/>
                <a:latin typeface="Calibri"/>
              </a:rPr>
              <a:t>Supp. Figure S4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: </a:t>
            </a: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(A)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 Total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distance traveled in the EPM of WT (WT5F) or GLUT5_KO mice (GLUT5_KO5F) fed a fructose 5% diet for 4 weeks or GLUT5_KO mice (GLUT5_KO0F) fed a control diet without any fructose for 4 weeks.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Calibri"/>
              </a:rPr>
              <a:t>(B) </a:t>
            </a: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Expression of the homeostatic genes (Glut5, Csf-1R, P2yr12 and Tgfbr2) quantified in microglia isolated from brains of WT (WT5F) or GLUT5_KO mice (GLUT5_KO5F) fed a fructose 5% diet for 4 weeks or GLUT5_KO mice (GLUT5_KO0F) fed a control diet without any fructose for 4 weeks. * p &lt; 0.05: One-way ANOVA followed by Holm-Šídák's multiple comparisons 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0" name="Objet 10"/>
          <p:cNvGraphicFramePr/>
          <p:nvPr/>
        </p:nvGraphicFramePr>
        <p:xfrm>
          <a:off x="592200" y="352440"/>
          <a:ext cx="1428840" cy="20019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91" name="Objet 10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92200" y="352440"/>
                    <a:ext cx="1428840" cy="2001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92" name="Image 11" descr=""/>
          <p:cNvPicPr/>
          <p:nvPr/>
        </p:nvPicPr>
        <p:blipFill>
          <a:blip r:embed="rId11"/>
          <a:stretch/>
        </p:blipFill>
        <p:spPr>
          <a:xfrm>
            <a:off x="93600" y="334800"/>
            <a:ext cx="727200" cy="758880"/>
          </a:xfrm>
          <a:prstGeom prst="rect">
            <a:avLst/>
          </a:prstGeom>
          <a:ln w="0">
            <a:noFill/>
          </a:ln>
        </p:spPr>
      </p:pic>
      <p:sp>
        <p:nvSpPr>
          <p:cNvPr id="93" name="ZoneTexte 12"/>
          <p:cNvSpPr/>
          <p:nvPr/>
        </p:nvSpPr>
        <p:spPr>
          <a:xfrm>
            <a:off x="-10440" y="32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ZoneTexte 13"/>
          <p:cNvSpPr/>
          <p:nvPr/>
        </p:nvSpPr>
        <p:spPr>
          <a:xfrm>
            <a:off x="-1080" y="253044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Image 1" descr=""/>
          <p:cNvPicPr/>
          <p:nvPr/>
        </p:nvPicPr>
        <p:blipFill>
          <a:blip r:embed="rId1"/>
          <a:stretch/>
        </p:blipFill>
        <p:spPr>
          <a:xfrm>
            <a:off x="409680" y="774720"/>
            <a:ext cx="5749920" cy="597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Image 1" descr=""/>
          <p:cNvPicPr/>
          <p:nvPr/>
        </p:nvPicPr>
        <p:blipFill>
          <a:blip r:embed="rId1"/>
          <a:stretch/>
        </p:blipFill>
        <p:spPr>
          <a:xfrm rot="16200000">
            <a:off x="-1025280" y="1782720"/>
            <a:ext cx="8909280" cy="557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2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26T15:30:28Z</dcterms:created>
  <dc:creator>Xavier Fioramonti</dc:creator>
  <dc:description/>
  <dc:language>en-US</dc:language>
  <cp:lastModifiedBy>Veronique Douard</cp:lastModifiedBy>
  <cp:lastPrinted>2024-04-22T11:03:43Z</cp:lastPrinted>
  <dcterms:modified xsi:type="dcterms:W3CDTF">2025-02-25T21:16:56Z</dcterms:modified>
  <cp:revision>98</cp:revision>
  <dc:subject/>
  <dc:title>Présentation PowerPoint</dc:title>
</cp:coreProperties>
</file>